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61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9F4D"/>
    <a:srgbClr val="F8B5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389"/>
    <p:restoredTop sz="83659"/>
  </p:normalViewPr>
  <p:slideViewPr>
    <p:cSldViewPr snapToGrid="0" snapToObjects="1">
      <p:cViewPr varScale="1">
        <p:scale>
          <a:sx n="79" d="100"/>
          <a:sy n="79" d="100"/>
        </p:scale>
        <p:origin x="10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3CF532-0012-6E4C-AE6E-658210682561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EC9674-6C6A-7F44-B719-E172203104AB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 Comparison of indicators in patients with negative bacterial culture before and after </a:t>
            </a:r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ropriate antibiotic therapy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BC= white blood cell count; NLR= neutrophil to lymphocyte ratio; PCT= </a:t>
            </a:r>
            <a:r>
              <a:rPr lang="en-US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calcitonin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CRP= C-reactive protein; nCD64 index= neutrophil CD64 index. Data in (A-H) were analyzed by the Wilcoxon signed ranks test, and expressed as mean ± </a:t>
            </a:r>
            <a:r>
              <a:rPr lang="en-US" altLang="zh-CN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D.</a:t>
            </a:r>
            <a:endParaRPr lang="zh-CN" altLang="zh-CN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EC9674-6C6A-7F44-B719-E172203104AB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.jpeg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0" Type="http://schemas.openxmlformats.org/officeDocument/2006/relationships/notesSlide" Target="../notesSlides/notesSlide1.xml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2918" y="3125603"/>
            <a:ext cx="2340000" cy="2880000"/>
          </a:xfrm>
          <a:prstGeom prst="rect">
            <a:avLst/>
          </a:prstGeom>
        </p:spPr>
      </p:pic>
      <p:pic>
        <p:nvPicPr>
          <p:cNvPr id="6" name="图片 5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8900" y="3125603"/>
            <a:ext cx="2340000" cy="2880000"/>
          </a:xfrm>
          <a:prstGeom prst="rect">
            <a:avLst/>
          </a:prstGeom>
        </p:spPr>
      </p:pic>
      <p:pic>
        <p:nvPicPr>
          <p:cNvPr id="7" name="图片 6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7833" y="3125603"/>
            <a:ext cx="2340000" cy="2880000"/>
          </a:xfrm>
          <a:prstGeom prst="rect">
            <a:avLst/>
          </a:prstGeom>
        </p:spPr>
      </p:pic>
      <p:pic>
        <p:nvPicPr>
          <p:cNvPr id="8" name="图片 7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99" y="3125603"/>
            <a:ext cx="2340000" cy="2880000"/>
          </a:xfrm>
          <a:prstGeom prst="rect">
            <a:avLst/>
          </a:prstGeom>
        </p:spPr>
      </p:pic>
      <p:pic>
        <p:nvPicPr>
          <p:cNvPr id="9" name="图片 8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1230" y="86103"/>
            <a:ext cx="3704400" cy="2880000"/>
          </a:xfrm>
          <a:prstGeom prst="rect">
            <a:avLst/>
          </a:prstGeom>
        </p:spPr>
      </p:pic>
      <p:pic>
        <p:nvPicPr>
          <p:cNvPr id="10" name="图片 9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5065" y="86103"/>
            <a:ext cx="2340000" cy="2880000"/>
          </a:xfrm>
          <a:prstGeom prst="rect">
            <a:avLst/>
          </a:prstGeom>
        </p:spPr>
      </p:pic>
      <p:pic>
        <p:nvPicPr>
          <p:cNvPr id="11" name="图片 10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1732" y="86103"/>
            <a:ext cx="2340000" cy="2880000"/>
          </a:xfrm>
          <a:prstGeom prst="rect">
            <a:avLst/>
          </a:prstGeom>
        </p:spPr>
      </p:pic>
      <p:pic>
        <p:nvPicPr>
          <p:cNvPr id="20" name="图片 19"/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99" y="86103"/>
            <a:ext cx="2340000" cy="288000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8971" y="55341"/>
            <a:ext cx="568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552700" y="55341"/>
            <a:ext cx="568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168900" y="55341"/>
            <a:ext cx="568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708900" y="55341"/>
            <a:ext cx="568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0800" y="3054030"/>
            <a:ext cx="568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554903" y="3058085"/>
            <a:ext cx="568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F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>
            <a:spLocks noChangeAspect="1"/>
          </p:cNvSpPr>
          <p:nvPr/>
        </p:nvSpPr>
        <p:spPr>
          <a:xfrm>
            <a:off x="5168900" y="3054030"/>
            <a:ext cx="482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G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>
            <a:spLocks noChangeAspect="1"/>
          </p:cNvSpPr>
          <p:nvPr/>
        </p:nvSpPr>
        <p:spPr>
          <a:xfrm>
            <a:off x="7762888" y="3054030"/>
            <a:ext cx="5140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H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98425" y="6190615"/>
            <a:ext cx="12141835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Arial Regular" panose="020B0604020202020204" charset="0"/>
                <a:cs typeface="Arial Regular" panose="020B0604020202020204" charset="0"/>
              </a:rPr>
              <a:t>Supplementary Figure 1 Comparison of indicators in patients with negative bacterial culture before and after appropriate antibiotic therapy.</a:t>
            </a:r>
            <a:endParaRPr lang="zh-CN" altLang="en-US" sz="1200">
              <a:latin typeface="Arial Regular" panose="020B0604020202020204" charset="0"/>
              <a:cs typeface="Arial Regular" panose="020B0604020202020204" charset="0"/>
            </a:endParaRPr>
          </a:p>
          <a:p>
            <a:r>
              <a:rPr lang="zh-CN" altLang="en-US" sz="1200">
                <a:latin typeface="Arial Regular" panose="020B0604020202020204" charset="0"/>
                <a:cs typeface="Arial Regular" panose="020B0604020202020204" charset="0"/>
              </a:rPr>
              <a:t>WBC= white blood cell count; NLR= neutrophil to lymphocyte ratio; PCT= procalcitonin; CRP= C-reactive protein; nCD64 index= neutrophil CD64 index. Data in (A-H) were analyzed by the Wilcoxon signed ranks test, and expressed as mean ± SD.</a:t>
            </a:r>
            <a:endParaRPr lang="zh-CN" altLang="en-US" sz="1200">
              <a:latin typeface="Arial Regular" panose="020B0604020202020204" charset="0"/>
              <a:cs typeface="Arial Regular" panose="020B06040202020202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1</Words>
  <Application>WPS 文字</Application>
  <PresentationFormat>宽屏</PresentationFormat>
  <Paragraphs>1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7" baseType="lpstr">
      <vt:lpstr>Arial</vt:lpstr>
      <vt:lpstr>宋体</vt:lpstr>
      <vt:lpstr>Wingdings</vt:lpstr>
      <vt:lpstr>Arial</vt:lpstr>
      <vt:lpstr>微软雅黑</vt:lpstr>
      <vt:lpstr>汉仪旗黑</vt:lpstr>
      <vt:lpstr>宋体</vt:lpstr>
      <vt:lpstr>Arial Unicode MS</vt:lpstr>
      <vt:lpstr>DengXian</vt:lpstr>
      <vt:lpstr>汉仪中等线KW</vt:lpstr>
      <vt:lpstr>汉仪书宋二KW</vt:lpstr>
      <vt:lpstr>DengXian Light</vt:lpstr>
      <vt:lpstr>Calibri</vt:lpstr>
      <vt:lpstr>Helvetica Neue</vt:lpstr>
      <vt:lpstr>Arial Regular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739730610@qq.com</dc:creator>
  <cp:lastModifiedBy>Edee</cp:lastModifiedBy>
  <cp:revision>46</cp:revision>
  <cp:lastPrinted>2022-08-28T13:55:48Z</cp:lastPrinted>
  <dcterms:created xsi:type="dcterms:W3CDTF">2022-08-28T13:55:48Z</dcterms:created>
  <dcterms:modified xsi:type="dcterms:W3CDTF">2022-08-28T13:55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8288A26DDCFA468E4730B63C76DE64D</vt:lpwstr>
  </property>
  <property fmtid="{D5CDD505-2E9C-101B-9397-08002B2CF9AE}" pid="3" name="KSOProductBuildVer">
    <vt:lpwstr>2052-4.4.1.7360</vt:lpwstr>
  </property>
</Properties>
</file>